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31" autoAdjust="0"/>
    <p:restoredTop sz="92633" autoAdjust="0"/>
  </p:normalViewPr>
  <p:slideViewPr>
    <p:cSldViewPr snapToGrid="0">
      <p:cViewPr varScale="1">
        <p:scale>
          <a:sx n="54" d="100"/>
          <a:sy n="54" d="100"/>
        </p:scale>
        <p:origin x="1293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E12105-F01E-4355-9C77-E549CE055FAE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476F91-AC0B-4DA4-B2C1-26EA3CEE74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8305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476F91-AC0B-4DA4-B2C1-26EA3CEE74C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686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695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896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969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936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964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124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729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415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830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314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853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F4586C-6169-4834-AB38-896CED854588}" type="datetimeFigureOut">
              <a:rPr lang="en-US" smtClean="0"/>
              <a:t>3/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581F8-BF17-469E-8346-6881FD60A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360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gif"/><Relationship Id="rId5" Type="http://schemas.openxmlformats.org/officeDocument/2006/relationships/image" Target="../media/image3.gif"/><Relationship Id="rId4" Type="http://schemas.openxmlformats.org/officeDocument/2006/relationships/image" Target="../media/image2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M5S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9551" y="465536"/>
            <a:ext cx="2560320" cy="2560320"/>
          </a:xfrm>
          <a:prstGeom prst="rect">
            <a:avLst/>
          </a:prstGeom>
        </p:spPr>
      </p:pic>
      <p:pic>
        <p:nvPicPr>
          <p:cNvPr id="21" name="M3S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9551" y="3057404"/>
            <a:ext cx="2560320" cy="256032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359070" y="126907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1606973" y="4152898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5747108" y="126907"/>
            <a:ext cx="10230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-atg5</a:t>
            </a:r>
            <a:r>
              <a:rPr lang="en-US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lang="en-US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1337669" y="1561030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6023" y="465536"/>
            <a:ext cx="2560320" cy="2560320"/>
          </a:xfrm>
          <a:prstGeom prst="rect">
            <a:avLst/>
          </a:prstGeom>
        </p:spPr>
      </p:pic>
      <p:pic>
        <p:nvPicPr>
          <p:cNvPr id="18" name="M2S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6023" y="3057404"/>
            <a:ext cx="2560320" cy="256032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365761" y="5895953"/>
            <a:ext cx="855472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vie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diac magnetic resonance imaging (MRI) in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and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-atg5</a:t>
            </a:r>
            <a:r>
              <a:rPr lang="en-US" sz="2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</a:t>
            </a:r>
            <a:r>
              <a:rPr lang="en-US" sz="2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at 3 months old. Cardiac MRI movies were made with Image J software.</a:t>
            </a:r>
          </a:p>
        </p:txBody>
      </p:sp>
    </p:spTree>
    <p:extLst>
      <p:ext uri="{BB962C8B-B14F-4D97-AF65-F5344CB8AC3E}">
        <p14:creationId xmlns:p14="http://schemas.microsoft.com/office/powerpoint/2010/main" val="2113704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5</TotalTime>
  <Words>38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g-Chang Hu</dc:creator>
  <cp:lastModifiedBy>Ming-Chang Hu</cp:lastModifiedBy>
  <cp:revision>70</cp:revision>
  <dcterms:created xsi:type="dcterms:W3CDTF">2019-07-04T16:38:40Z</dcterms:created>
  <dcterms:modified xsi:type="dcterms:W3CDTF">2021-03-07T03:46:29Z</dcterms:modified>
</cp:coreProperties>
</file>